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ar-S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9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BDD26-3129-D2C2-111C-08065FBBE8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DB9CF0-686A-75D1-643A-5A183692D9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ar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D608A0-7A3E-8806-1443-AE4F3EBF0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32477C-7069-1FBB-6055-70CDB30BA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E48882-276D-3D61-1D65-BE6511D81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703416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9C50AA-3209-053F-A27D-8E71D49CA5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EDAE5A-AC32-3997-6520-A5A70DC074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22BC5C-1BAF-6249-B52C-A62F91CD1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5B61A6-03CB-4CE6-9826-E162971C2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C152C0-55C4-F196-C754-16235A16F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950002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75DC5C4-BEE4-6ED8-27F7-4981DBC8DD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F8720E-54B9-F321-657E-01C96A768B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928AAD-8874-D23C-7F4A-2D72DCF5A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5F1EAC-1716-FEAE-ACFC-857981EF4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68BC7B-8AF7-9515-5609-BB82C7645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061777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956C8-CEA0-F633-37E5-1D40C46629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F649EF-BCEA-E149-BB2C-101BC88D86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639A8-77DB-26D7-48F8-33F724056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4D6E46-4537-DCFD-DCBA-03BCDDCC6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917E1D-DF94-6AA8-D8E8-61EDBA5E0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2768208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5E7EE-CBC3-2DCD-762F-921B018D6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47747B-DEEC-457D-F779-B71D1B9FF9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89E4D1-C209-E573-89C7-B8C1E7FD0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AE84FF-ECF3-8DF2-5680-E5DFCEF98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AE923D-AB92-C242-2C51-A47794AD2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11581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534C74-A12E-D6D6-79A6-A2E09EB300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289479-8A03-883A-58EE-D041F8C0A7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36C264-D8C0-1470-4DE3-BB8583F548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EA2F3C-A3C6-2F2F-DA58-672CCE395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FFD4B7-BC46-F289-BF71-3D1532B1D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653677-8C37-EF57-A583-883272641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223315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3F40B9-CED2-65BD-0F74-634632AA9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6E0242-ADE5-571F-47C1-1C47DCDDEE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AAB351-E2F4-DDAB-1F0F-514B56DDD8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D5D406-0EEA-1563-940F-DA352FE47A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C5BD45-1313-712F-BF29-106084B6E9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54CECF-7B28-B205-63B1-FF27EFEFF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580DD2-460A-4407-0916-C51361D2F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D9EB4B-9655-F0E2-CA97-65E6D5C15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710143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0D06E8-A418-1739-4C46-D2C1C688E4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7420F0-D0A4-6DA0-FEDD-4CBAA92A9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34BAE0-3FDD-C062-4C16-9C8D4D7B5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807D60-685B-60A2-BDEE-DCADC557E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2056161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DFDC29-EC5B-A329-68A3-E64B1556F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B61D9CE-1C58-2EFB-425F-AFA7CFBF7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1AD913A-94BC-58F8-20E0-7904E05E6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686386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7922F-2C07-D6B6-E434-8811325245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DBA2F8-137A-2D58-27DC-79FE27DD62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FD66B4-E087-88A3-E844-ADCB445416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EF0144-FD27-1AE8-85B4-E75AD9D4D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6C7054-606E-7DD9-0C43-32F736760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D68991-F0F2-656F-13CB-EB6BEF751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905489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3D8650-7AA3-739C-6E79-0F7A75CB39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0B41EE-099A-E0E6-7677-9E87907EA2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ar-S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4D0003-9448-A8FF-67B6-2783F8F01F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9E2BC2-2568-3282-2A18-7E7A73A6B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50F80B-B4B1-EB67-6CDD-E9CD8A41F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82EA7F-0F20-F5F1-16F2-74B7DF85E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272527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44B6C47-88A5-106D-6030-B2A1C8627F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ar-S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2B4A7C-6FF3-4DA9-08DD-5FC8994B07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S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AF1AD5-B235-CA21-6EDA-7322FEAA65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83C0F-7130-42F1-83CA-68A81F70FC96}" type="datetimeFigureOut">
              <a:rPr lang="ar-SA" smtClean="0"/>
              <a:t>08/11/1444</a:t>
            </a:fld>
            <a:endParaRPr lang="ar-S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2B7087-7C20-0B37-905E-A505E44602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S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3DC5A6-ACB7-D616-62B6-3EDA477C68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E8CB8-61B6-4C66-B647-9948FEC39EB0}" type="slidenum">
              <a:rPr lang="ar-SA" smtClean="0"/>
              <a:t>‹#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861175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ar-SA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>
            <a:extLst>
              <a:ext uri="{FF2B5EF4-FFF2-40B4-BE49-F238E27FC236}">
                <a16:creationId xmlns:a16="http://schemas.microsoft.com/office/drawing/2014/main" id="{78CC2C88-2BE5-F559-C2AD-4BA81E89D339}"/>
              </a:ext>
            </a:extLst>
          </p:cNvPr>
          <p:cNvGrpSpPr/>
          <p:nvPr/>
        </p:nvGrpSpPr>
        <p:grpSpPr>
          <a:xfrm>
            <a:off x="222467" y="139422"/>
            <a:ext cx="11311638" cy="5782407"/>
            <a:chOff x="734626" y="825221"/>
            <a:chExt cx="11311638" cy="578240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3E924CB-7870-FE2E-B6A2-DC2A78265B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41" t="19362" r="5275" b="16930"/>
            <a:stretch/>
          </p:blipFill>
          <p:spPr bwMode="auto">
            <a:xfrm>
              <a:off x="1796145" y="1349829"/>
              <a:ext cx="10250119" cy="5257799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1E28A253-E8B9-3030-079D-CE9B7DCD0A9D}"/>
                </a:ext>
              </a:extLst>
            </p:cNvPr>
            <p:cNvSpPr/>
            <p:nvPr/>
          </p:nvSpPr>
          <p:spPr>
            <a:xfrm>
              <a:off x="2025964" y="852438"/>
              <a:ext cx="849087" cy="59159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M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DE32F3CA-E54D-0F1F-B387-010CD9B639AB}"/>
                </a:ext>
              </a:extLst>
            </p:cNvPr>
            <p:cNvSpPr/>
            <p:nvPr/>
          </p:nvSpPr>
          <p:spPr>
            <a:xfrm>
              <a:off x="3354021" y="837782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1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AEFE3AC-2FB9-B6A1-865C-BE9EFDD91C4B}"/>
                </a:ext>
              </a:extLst>
            </p:cNvPr>
            <p:cNvSpPr/>
            <p:nvPr/>
          </p:nvSpPr>
          <p:spPr>
            <a:xfrm>
              <a:off x="4562336" y="837782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2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83BD659-4CC9-0B32-EDEE-4939F1299CDB}"/>
                </a:ext>
              </a:extLst>
            </p:cNvPr>
            <p:cNvSpPr/>
            <p:nvPr/>
          </p:nvSpPr>
          <p:spPr>
            <a:xfrm>
              <a:off x="5707774" y="837782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3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86BE1C5-5A4A-8A3C-2536-580CB99D53F3}"/>
                </a:ext>
              </a:extLst>
            </p:cNvPr>
            <p:cNvSpPr/>
            <p:nvPr/>
          </p:nvSpPr>
          <p:spPr>
            <a:xfrm>
              <a:off x="6949027" y="825221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4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2918E2EF-D8CC-DF1F-88FE-B30122B51CC5}"/>
                </a:ext>
              </a:extLst>
            </p:cNvPr>
            <p:cNvSpPr/>
            <p:nvPr/>
          </p:nvSpPr>
          <p:spPr>
            <a:xfrm>
              <a:off x="8196659" y="837782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5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1C88FC8-52ED-B0D9-C5AE-C6B68BDEC3CF}"/>
                </a:ext>
              </a:extLst>
            </p:cNvPr>
            <p:cNvSpPr/>
            <p:nvPr/>
          </p:nvSpPr>
          <p:spPr>
            <a:xfrm>
              <a:off x="9525001" y="844905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6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95BBFAC-1452-1F3A-5FE7-ED92A9F7096C}"/>
                </a:ext>
              </a:extLst>
            </p:cNvPr>
            <p:cNvSpPr/>
            <p:nvPr/>
          </p:nvSpPr>
          <p:spPr>
            <a:xfrm>
              <a:off x="10853343" y="834019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7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4FA9451D-9F36-BE6C-E888-6B290BC60233}"/>
                </a:ext>
              </a:extLst>
            </p:cNvPr>
            <p:cNvCxnSpPr/>
            <p:nvPr/>
          </p:nvCxnSpPr>
          <p:spPr>
            <a:xfrm flipH="1">
              <a:off x="1372822" y="1796143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C6F396EA-3040-51CF-3974-CACBD613A889}"/>
                </a:ext>
              </a:extLst>
            </p:cNvPr>
            <p:cNvCxnSpPr/>
            <p:nvPr/>
          </p:nvCxnSpPr>
          <p:spPr>
            <a:xfrm flipH="1">
              <a:off x="1372821" y="2032665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E2601923-0A48-1DDD-B6B8-D1F8C12936CB}"/>
                </a:ext>
              </a:extLst>
            </p:cNvPr>
            <p:cNvCxnSpPr/>
            <p:nvPr/>
          </p:nvCxnSpPr>
          <p:spPr>
            <a:xfrm flipH="1">
              <a:off x="1374040" y="2275115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53430619-FC61-C3B5-2C5E-4EC5843AE958}"/>
                </a:ext>
              </a:extLst>
            </p:cNvPr>
            <p:cNvCxnSpPr/>
            <p:nvPr/>
          </p:nvCxnSpPr>
          <p:spPr>
            <a:xfrm flipH="1">
              <a:off x="1372820" y="2743201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8652C4C0-E7DF-89EE-E8E7-EB7FCEE01353}"/>
                </a:ext>
              </a:extLst>
            </p:cNvPr>
            <p:cNvCxnSpPr/>
            <p:nvPr/>
          </p:nvCxnSpPr>
          <p:spPr>
            <a:xfrm flipH="1">
              <a:off x="1372819" y="3055329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E3EA1760-39A4-4F82-FB67-9CC3DB845FA9}"/>
                </a:ext>
              </a:extLst>
            </p:cNvPr>
            <p:cNvCxnSpPr/>
            <p:nvPr/>
          </p:nvCxnSpPr>
          <p:spPr>
            <a:xfrm flipH="1">
              <a:off x="1372819" y="3265715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B3C2AE45-0BF3-E6A8-C012-8EBDA26810FA}"/>
                </a:ext>
              </a:extLst>
            </p:cNvPr>
            <p:cNvCxnSpPr/>
            <p:nvPr/>
          </p:nvCxnSpPr>
          <p:spPr>
            <a:xfrm flipH="1">
              <a:off x="1367379" y="3482344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055D0EA9-3644-AF27-9998-1F16C935985B}"/>
                </a:ext>
              </a:extLst>
            </p:cNvPr>
            <p:cNvCxnSpPr/>
            <p:nvPr/>
          </p:nvCxnSpPr>
          <p:spPr>
            <a:xfrm flipH="1">
              <a:off x="1374039" y="3765371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CA90CB1F-DE1E-5A09-9DAF-92449805DDAF}"/>
                </a:ext>
              </a:extLst>
            </p:cNvPr>
            <p:cNvCxnSpPr/>
            <p:nvPr/>
          </p:nvCxnSpPr>
          <p:spPr>
            <a:xfrm flipH="1">
              <a:off x="1361937" y="4060370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885310AD-4A8A-70D8-FEAF-CEEAAAF440EA}"/>
                </a:ext>
              </a:extLst>
            </p:cNvPr>
            <p:cNvCxnSpPr/>
            <p:nvPr/>
          </p:nvCxnSpPr>
          <p:spPr>
            <a:xfrm flipH="1">
              <a:off x="1372819" y="4517569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D8749C5B-B007-FF4C-503A-CD879FCC2869}"/>
                </a:ext>
              </a:extLst>
            </p:cNvPr>
            <p:cNvCxnSpPr/>
            <p:nvPr/>
          </p:nvCxnSpPr>
          <p:spPr>
            <a:xfrm flipH="1">
              <a:off x="1372823" y="5007427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046802FC-3D14-114B-0F84-7EFCD245EDFE}"/>
                </a:ext>
              </a:extLst>
            </p:cNvPr>
            <p:cNvCxnSpPr/>
            <p:nvPr/>
          </p:nvCxnSpPr>
          <p:spPr>
            <a:xfrm flipH="1">
              <a:off x="1361936" y="5693227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E1E43215-4938-8612-9EB0-E21680DA3564}"/>
                </a:ext>
              </a:extLst>
            </p:cNvPr>
            <p:cNvSpPr/>
            <p:nvPr/>
          </p:nvSpPr>
          <p:spPr>
            <a:xfrm>
              <a:off x="756411" y="1660419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30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4A502433-D27B-9A9C-077D-0D8CFE2887E6}"/>
                </a:ext>
              </a:extLst>
            </p:cNvPr>
            <p:cNvSpPr/>
            <p:nvPr/>
          </p:nvSpPr>
          <p:spPr>
            <a:xfrm>
              <a:off x="756411" y="1893067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20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892261E5-3689-B13E-6EEA-44BD35E05344}"/>
                </a:ext>
              </a:extLst>
            </p:cNvPr>
            <p:cNvSpPr/>
            <p:nvPr/>
          </p:nvSpPr>
          <p:spPr>
            <a:xfrm>
              <a:off x="756411" y="2149191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15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DCB54A0E-08E1-4AA8-7C8F-29E6F69C4CC1}"/>
                </a:ext>
              </a:extLst>
            </p:cNvPr>
            <p:cNvSpPr/>
            <p:nvPr/>
          </p:nvSpPr>
          <p:spPr>
            <a:xfrm>
              <a:off x="756411" y="2616138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10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AE853BE9-6612-745A-84ED-02A11081D41A}"/>
                </a:ext>
              </a:extLst>
            </p:cNvPr>
            <p:cNvSpPr/>
            <p:nvPr/>
          </p:nvSpPr>
          <p:spPr>
            <a:xfrm>
              <a:off x="783691" y="2905607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8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3E359FEE-87F6-833F-7554-652ADBC7CAD8}"/>
                </a:ext>
              </a:extLst>
            </p:cNvPr>
            <p:cNvSpPr/>
            <p:nvPr/>
          </p:nvSpPr>
          <p:spPr>
            <a:xfrm>
              <a:off x="783691" y="3101343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7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A7FFB738-BD47-2213-AD4F-E20A7F7080BE}"/>
                </a:ext>
              </a:extLst>
            </p:cNvPr>
            <p:cNvSpPr/>
            <p:nvPr/>
          </p:nvSpPr>
          <p:spPr>
            <a:xfrm>
              <a:off x="783691" y="3340288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6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A100CECA-105F-FDB0-F4C8-1E3EC9022689}"/>
                </a:ext>
              </a:extLst>
            </p:cNvPr>
            <p:cNvSpPr/>
            <p:nvPr/>
          </p:nvSpPr>
          <p:spPr>
            <a:xfrm>
              <a:off x="783691" y="3634745"/>
              <a:ext cx="854530" cy="24928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5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0DE23CCE-6351-3DD0-7C4C-94B76ADAAF82}"/>
                </a:ext>
              </a:extLst>
            </p:cNvPr>
            <p:cNvSpPr/>
            <p:nvPr/>
          </p:nvSpPr>
          <p:spPr>
            <a:xfrm>
              <a:off x="734626" y="3929202"/>
              <a:ext cx="952660" cy="26016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4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A974EC4D-3457-639E-ABE0-597D2A686E02}"/>
                </a:ext>
              </a:extLst>
            </p:cNvPr>
            <p:cNvSpPr/>
            <p:nvPr/>
          </p:nvSpPr>
          <p:spPr>
            <a:xfrm>
              <a:off x="783691" y="4378239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3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CEBDC617-7B4B-4691-C994-345B061F6A9A}"/>
                </a:ext>
              </a:extLst>
            </p:cNvPr>
            <p:cNvSpPr/>
            <p:nvPr/>
          </p:nvSpPr>
          <p:spPr>
            <a:xfrm>
              <a:off x="783691" y="4874625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2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FAE2CF02-4828-E918-4E3D-A361EB5A950B}"/>
                </a:ext>
              </a:extLst>
            </p:cNvPr>
            <p:cNvSpPr/>
            <p:nvPr/>
          </p:nvSpPr>
          <p:spPr>
            <a:xfrm>
              <a:off x="783691" y="5562848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1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B4F8E07A-4452-F51D-9271-3B44E53BE14C}"/>
              </a:ext>
            </a:extLst>
          </p:cNvPr>
          <p:cNvSpPr txBox="1"/>
          <p:nvPr/>
        </p:nvSpPr>
        <p:spPr>
          <a:xfrm>
            <a:off x="1175657" y="6121275"/>
            <a:ext cx="9840686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. 4: Gel electrophoresis results of the </a:t>
            </a:r>
            <a:r>
              <a:rPr lang="en-GB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Wolbachia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train identification PCR assays for </a:t>
            </a:r>
            <a:r>
              <a:rPr lang="en-GB" sz="2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e. aegypti 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using the </a:t>
            </a:r>
            <a:r>
              <a:rPr lang="en-GB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wsp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ene, M: Marker, 1 negative control, sample from 2: 7</a:t>
            </a:r>
            <a:endParaRPr lang="ar-SA" dirty="0"/>
          </a:p>
        </p:txBody>
      </p:sp>
    </p:spTree>
    <p:extLst>
      <p:ext uri="{BB962C8B-B14F-4D97-AF65-F5344CB8AC3E}">
        <p14:creationId xmlns:p14="http://schemas.microsoft.com/office/powerpoint/2010/main" val="2551468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>
            <a:extLst>
              <a:ext uri="{FF2B5EF4-FFF2-40B4-BE49-F238E27FC236}">
                <a16:creationId xmlns:a16="http://schemas.microsoft.com/office/drawing/2014/main" id="{E3460265-15BC-E95A-CB83-1F065087C75B}"/>
              </a:ext>
            </a:extLst>
          </p:cNvPr>
          <p:cNvGrpSpPr/>
          <p:nvPr/>
        </p:nvGrpSpPr>
        <p:grpSpPr>
          <a:xfrm>
            <a:off x="298425" y="229924"/>
            <a:ext cx="10721637" cy="5546510"/>
            <a:chOff x="1125739" y="1057238"/>
            <a:chExt cx="10721637" cy="554651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69DA63A-FF7D-1AD3-4959-CFC0694FB9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73" t="6714" r="3072" b="19170"/>
            <a:stretch/>
          </p:blipFill>
          <p:spPr bwMode="auto">
            <a:xfrm>
              <a:off x="2209800" y="1574724"/>
              <a:ext cx="9637576" cy="5029024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7888A112-A1E1-4E66-1401-46C33C61C305}"/>
                </a:ext>
              </a:extLst>
            </p:cNvPr>
            <p:cNvSpPr/>
            <p:nvPr/>
          </p:nvSpPr>
          <p:spPr>
            <a:xfrm>
              <a:off x="2400302" y="1089895"/>
              <a:ext cx="849087" cy="59159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M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90CF5986-0818-17FE-2DA5-E400BC9A4A86}"/>
                </a:ext>
              </a:extLst>
            </p:cNvPr>
            <p:cNvSpPr/>
            <p:nvPr/>
          </p:nvSpPr>
          <p:spPr>
            <a:xfrm>
              <a:off x="3439891" y="1057238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1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17F1E539-476C-C434-4E69-6D712B0A63B7}"/>
                </a:ext>
              </a:extLst>
            </p:cNvPr>
            <p:cNvSpPr/>
            <p:nvPr/>
          </p:nvSpPr>
          <p:spPr>
            <a:xfrm>
              <a:off x="4542962" y="1057238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2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A5B7F4D6-8E29-2D6D-D0BE-6E59243A09CE}"/>
                </a:ext>
              </a:extLst>
            </p:cNvPr>
            <p:cNvSpPr/>
            <p:nvPr/>
          </p:nvSpPr>
          <p:spPr>
            <a:xfrm>
              <a:off x="5790594" y="1079010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3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088D9230-BA32-1249-227D-AFC1F5755ABD}"/>
                </a:ext>
              </a:extLst>
            </p:cNvPr>
            <p:cNvSpPr/>
            <p:nvPr/>
          </p:nvSpPr>
          <p:spPr>
            <a:xfrm>
              <a:off x="6992571" y="1057238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4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61B1C8D-BF1C-0428-1C30-4430D6F4614C}"/>
                </a:ext>
              </a:extLst>
            </p:cNvPr>
            <p:cNvSpPr/>
            <p:nvPr/>
          </p:nvSpPr>
          <p:spPr>
            <a:xfrm>
              <a:off x="8240203" y="1057238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5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7CA014A4-C573-83D4-143B-EA777B9C65CA}"/>
                </a:ext>
              </a:extLst>
            </p:cNvPr>
            <p:cNvSpPr/>
            <p:nvPr/>
          </p:nvSpPr>
          <p:spPr>
            <a:xfrm>
              <a:off x="9568545" y="1079010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6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FE3353EF-33AB-02EB-01E7-F0C239210AF4}"/>
                </a:ext>
              </a:extLst>
            </p:cNvPr>
            <p:cNvSpPr/>
            <p:nvPr/>
          </p:nvSpPr>
          <p:spPr>
            <a:xfrm>
              <a:off x="10813373" y="1079010"/>
              <a:ext cx="849087" cy="646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3200" b="1" dirty="0">
                  <a:solidFill>
                    <a:schemeClr val="tx1"/>
                  </a:solidFill>
                </a:rPr>
                <a:t>7</a:t>
              </a:r>
              <a:endParaRPr lang="ar-SA" sz="3200" b="1" dirty="0">
                <a:solidFill>
                  <a:schemeClr val="tx1"/>
                </a:solidFill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0160A014-F280-A347-3C62-03C72C9D230E}"/>
                </a:ext>
              </a:extLst>
            </p:cNvPr>
            <p:cNvCxnSpPr/>
            <p:nvPr/>
          </p:nvCxnSpPr>
          <p:spPr>
            <a:xfrm flipH="1">
              <a:off x="1816297" y="2636728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2C71F8BA-9C85-0D72-C42E-61F3149F9F03}"/>
                </a:ext>
              </a:extLst>
            </p:cNvPr>
            <p:cNvCxnSpPr/>
            <p:nvPr/>
          </p:nvCxnSpPr>
          <p:spPr>
            <a:xfrm flipH="1">
              <a:off x="1808983" y="2818486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BA1F232B-1129-4FBC-6B63-6F02DB738F43}"/>
                </a:ext>
              </a:extLst>
            </p:cNvPr>
            <p:cNvCxnSpPr/>
            <p:nvPr/>
          </p:nvCxnSpPr>
          <p:spPr>
            <a:xfrm flipH="1">
              <a:off x="1796143" y="3015614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B3A01801-4FBB-E2A2-8DBC-9C07F09FA332}"/>
                </a:ext>
              </a:extLst>
            </p:cNvPr>
            <p:cNvCxnSpPr/>
            <p:nvPr/>
          </p:nvCxnSpPr>
          <p:spPr>
            <a:xfrm flipH="1">
              <a:off x="1771931" y="3352265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8ED64D00-A2C9-F4C3-8D80-D7D6C0DF7FC8}"/>
                </a:ext>
              </a:extLst>
            </p:cNvPr>
            <p:cNvCxnSpPr/>
            <p:nvPr/>
          </p:nvCxnSpPr>
          <p:spPr>
            <a:xfrm flipH="1">
              <a:off x="1743300" y="3557161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4737BA7E-3623-D356-27D8-5DDD6B9A285A}"/>
                </a:ext>
              </a:extLst>
            </p:cNvPr>
            <p:cNvCxnSpPr/>
            <p:nvPr/>
          </p:nvCxnSpPr>
          <p:spPr>
            <a:xfrm flipH="1">
              <a:off x="1716835" y="3711733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C0A39976-FB1F-E36D-8DA0-2B35CC4492E5}"/>
                </a:ext>
              </a:extLst>
            </p:cNvPr>
            <p:cNvCxnSpPr/>
            <p:nvPr/>
          </p:nvCxnSpPr>
          <p:spPr>
            <a:xfrm flipH="1">
              <a:off x="1735053" y="3888366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B730E026-42F9-C217-FCEA-954425E408D8}"/>
                </a:ext>
              </a:extLst>
            </p:cNvPr>
            <p:cNvCxnSpPr/>
            <p:nvPr/>
          </p:nvCxnSpPr>
          <p:spPr>
            <a:xfrm flipH="1">
              <a:off x="1743300" y="4058493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3335C253-108E-B5E9-887E-8FC58D77CAB0}"/>
                </a:ext>
              </a:extLst>
            </p:cNvPr>
            <p:cNvCxnSpPr/>
            <p:nvPr/>
          </p:nvCxnSpPr>
          <p:spPr>
            <a:xfrm flipH="1">
              <a:off x="1752968" y="4337477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33388226-F18F-49EB-E644-AEB32A2E7973}"/>
                </a:ext>
              </a:extLst>
            </p:cNvPr>
            <p:cNvCxnSpPr/>
            <p:nvPr/>
          </p:nvCxnSpPr>
          <p:spPr>
            <a:xfrm flipH="1">
              <a:off x="1752968" y="4627816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129647F3-E432-EC68-F944-09755357B62B}"/>
                </a:ext>
              </a:extLst>
            </p:cNvPr>
            <p:cNvCxnSpPr/>
            <p:nvPr/>
          </p:nvCxnSpPr>
          <p:spPr>
            <a:xfrm flipH="1">
              <a:off x="1752968" y="5006643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1CCF5204-DC4D-D235-A2B1-EFD02A108F80}"/>
                </a:ext>
              </a:extLst>
            </p:cNvPr>
            <p:cNvCxnSpPr/>
            <p:nvPr/>
          </p:nvCxnSpPr>
          <p:spPr>
            <a:xfrm flipH="1">
              <a:off x="1752968" y="5543856"/>
              <a:ext cx="7075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9640B733-D05B-526B-D0BE-D008319A9DFC}"/>
                </a:ext>
              </a:extLst>
            </p:cNvPr>
            <p:cNvSpPr/>
            <p:nvPr/>
          </p:nvSpPr>
          <p:spPr>
            <a:xfrm>
              <a:off x="1199886" y="2501004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30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C3CC8ACE-2288-DA45-F5A8-E4C034678712}"/>
                </a:ext>
              </a:extLst>
            </p:cNvPr>
            <p:cNvSpPr/>
            <p:nvPr/>
          </p:nvSpPr>
          <p:spPr>
            <a:xfrm>
              <a:off x="1192573" y="2678888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20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5A61B8D-42AC-6198-0150-77F1B5C6F74A}"/>
                </a:ext>
              </a:extLst>
            </p:cNvPr>
            <p:cNvSpPr/>
            <p:nvPr/>
          </p:nvSpPr>
          <p:spPr>
            <a:xfrm>
              <a:off x="1178514" y="2889690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15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1E06B435-463D-34C2-90B4-272A5ACD516A}"/>
                </a:ext>
              </a:extLst>
            </p:cNvPr>
            <p:cNvSpPr/>
            <p:nvPr/>
          </p:nvSpPr>
          <p:spPr>
            <a:xfrm>
              <a:off x="1155522" y="3225202"/>
              <a:ext cx="854530" cy="2650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10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6DD1DFBF-B5B6-D65B-4E79-48D919189053}"/>
                </a:ext>
              </a:extLst>
            </p:cNvPr>
            <p:cNvSpPr/>
            <p:nvPr/>
          </p:nvSpPr>
          <p:spPr>
            <a:xfrm>
              <a:off x="1154172" y="3407439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8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A185B0ED-2ACF-5EB2-1F76-B10D2051C6F4}"/>
                </a:ext>
              </a:extLst>
            </p:cNvPr>
            <p:cNvSpPr/>
            <p:nvPr/>
          </p:nvSpPr>
          <p:spPr>
            <a:xfrm>
              <a:off x="1127707" y="3547361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7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D87A2030-B4BA-A0AE-2499-D194337848E1}"/>
                </a:ext>
              </a:extLst>
            </p:cNvPr>
            <p:cNvSpPr/>
            <p:nvPr/>
          </p:nvSpPr>
          <p:spPr>
            <a:xfrm>
              <a:off x="1151365" y="3746310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6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1ECC4421-8D12-9EB6-0B60-95AD62EE5D41}"/>
                </a:ext>
              </a:extLst>
            </p:cNvPr>
            <p:cNvSpPr/>
            <p:nvPr/>
          </p:nvSpPr>
          <p:spPr>
            <a:xfrm>
              <a:off x="1152952" y="3927867"/>
              <a:ext cx="854530" cy="24928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5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673E9721-4C1E-422E-DCDB-305B0E48EE39}"/>
                </a:ext>
              </a:extLst>
            </p:cNvPr>
            <p:cNvSpPr/>
            <p:nvPr/>
          </p:nvSpPr>
          <p:spPr>
            <a:xfrm>
              <a:off x="1125739" y="4190759"/>
              <a:ext cx="952660" cy="26016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4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9A24A446-C09B-25C7-0C9E-54DEC0FBF7AE}"/>
                </a:ext>
              </a:extLst>
            </p:cNvPr>
            <p:cNvSpPr/>
            <p:nvPr/>
          </p:nvSpPr>
          <p:spPr>
            <a:xfrm>
              <a:off x="1188496" y="4491447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3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3B9E0C25-47E3-9C61-4080-E0F7243F5422}"/>
                </a:ext>
              </a:extLst>
            </p:cNvPr>
            <p:cNvSpPr/>
            <p:nvPr/>
          </p:nvSpPr>
          <p:spPr>
            <a:xfrm>
              <a:off x="1165138" y="4875411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2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9DFED0B9-9535-AA05-292F-DC81BCC278FF}"/>
                </a:ext>
              </a:extLst>
            </p:cNvPr>
            <p:cNvSpPr/>
            <p:nvPr/>
          </p:nvSpPr>
          <p:spPr>
            <a:xfrm>
              <a:off x="1174804" y="5411310"/>
              <a:ext cx="854530" cy="283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r>
                <a:rPr lang="en-GB" sz="1200" dirty="0">
                  <a:solidFill>
                    <a:schemeClr val="tx1"/>
                  </a:solidFill>
                </a:rPr>
                <a:t>100</a:t>
              </a:r>
              <a:endParaRPr lang="ar-SA" sz="1200" dirty="0">
                <a:solidFill>
                  <a:schemeClr val="tx1"/>
                </a:solidFill>
              </a:endParaRP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8A26A8F4-3CA0-13BF-45C0-26FAE2FE1F27}"/>
              </a:ext>
            </a:extLst>
          </p:cNvPr>
          <p:cNvSpPr txBox="1"/>
          <p:nvPr/>
        </p:nvSpPr>
        <p:spPr>
          <a:xfrm>
            <a:off x="799837" y="6055417"/>
            <a:ext cx="10678886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 5: Gel electrophoresis results of the </a:t>
            </a:r>
            <a:r>
              <a:rPr lang="en-GB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olbachia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train identification PCR assays for </a:t>
            </a:r>
            <a:r>
              <a:rPr lang="en-GB" sz="2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Ae. aegypti 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using the 16S rRNA gene, M: Marker, 1 negative control sample from 2:7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3115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110</Words>
  <Application>Microsoft Office PowerPoint</Application>
  <PresentationFormat>Widescreen</PresentationFormat>
  <Paragraphs>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د. سمية شعراوي</dc:creator>
  <cp:lastModifiedBy>د. سمية شعراوي</cp:lastModifiedBy>
  <cp:revision>3</cp:revision>
  <dcterms:created xsi:type="dcterms:W3CDTF">2023-05-27T12:31:26Z</dcterms:created>
  <dcterms:modified xsi:type="dcterms:W3CDTF">2023-05-27T14:03:42Z</dcterms:modified>
</cp:coreProperties>
</file>